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1EF80F-6B1F-420F-9C44-FE87A06121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5D6CE4-28A3-4189-9343-FDE36E7365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8ADFE4-A0D2-4CC8-A835-506C2316FF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E32DD9-11EA-45AD-9C69-7A6F6B51E1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D2BEAC-B7F9-45D8-8C2C-4E615F0687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47329C-E41D-476C-AD2E-2CC2D3FF9E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004F98-9C38-457D-BFC2-EE1DB0A17F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673DA1-DDE4-4577-BA6A-15E8E63EBB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9627A2-5DB1-4DD8-84E9-F62F083DD4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6314E4-7101-4273-B648-C7135131A6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78079B-6F06-4C7B-BE27-E5DDDCFBC5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6A40B5-5C57-4692-B4D9-04C54E8853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E00BDF-E051-4FF8-83AF-996A70FB3DE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70"/>
          <p:cNvSpPr/>
          <p:nvPr/>
        </p:nvSpPr>
        <p:spPr>
          <a:xfrm>
            <a:off x="1285920" y="4076640"/>
            <a:ext cx="471492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Fig. S6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olonic autophagy was noted to be induced by LKM512 treatment.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Lysates of colonic tissue derived from 21-month-old LKM512 mice and control mice were subjected to immunoblot analysis with an anti-LC3 antibody. The positions of β-actin as a positive control, LC3-I, and LC3-II are indicated here. The LC3-I/LC3-II ratio in the LKM512-treated mice was lower than that in control mice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2928960" y="1857240"/>
            <a:ext cx="1212840" cy="1928880"/>
          </a:xfrm>
          <a:prstGeom prst="rect">
            <a:avLst/>
          </a:prstGeom>
          <a:ln w="0">
            <a:noFill/>
          </a:ln>
        </p:spPr>
      </p:pic>
      <p:sp>
        <p:nvSpPr>
          <p:cNvPr id="43" name="テキスト ボックス 3"/>
          <p:cNvSpPr/>
          <p:nvPr/>
        </p:nvSpPr>
        <p:spPr>
          <a:xfrm>
            <a:off x="3429000" y="164448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KM5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4"/>
          <p:cNvSpPr/>
          <p:nvPr/>
        </p:nvSpPr>
        <p:spPr>
          <a:xfrm>
            <a:off x="2881440" y="1643040"/>
            <a:ext cx="64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5"/>
          <p:cNvSpPr/>
          <p:nvPr/>
        </p:nvSpPr>
        <p:spPr>
          <a:xfrm>
            <a:off x="2262240" y="3059280"/>
            <a:ext cx="571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C3-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テキスト ボックス 6"/>
          <p:cNvSpPr/>
          <p:nvPr/>
        </p:nvSpPr>
        <p:spPr>
          <a:xfrm>
            <a:off x="2262240" y="3325680"/>
            <a:ext cx="571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C3-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直線コネクタ 12"/>
          <p:cNvSpPr/>
          <p:nvPr/>
        </p:nvSpPr>
        <p:spPr>
          <a:xfrm>
            <a:off x="2714760" y="3197160"/>
            <a:ext cx="2142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直線コネクタ 13"/>
          <p:cNvSpPr/>
          <p:nvPr/>
        </p:nvSpPr>
        <p:spPr>
          <a:xfrm>
            <a:off x="2714760" y="3438360"/>
            <a:ext cx="2142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5"/>
          <p:cNvSpPr/>
          <p:nvPr/>
        </p:nvSpPr>
        <p:spPr>
          <a:xfrm>
            <a:off x="2228760" y="1924200"/>
            <a:ext cx="571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β-a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直線コネクタ 10"/>
          <p:cNvSpPr/>
          <p:nvPr/>
        </p:nvSpPr>
        <p:spPr>
          <a:xfrm>
            <a:off x="2714760" y="2071800"/>
            <a:ext cx="2142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07T13:57:50Z</dcterms:created>
  <dc:creator>Mitsuharu Matsumoto</dc:creator>
  <dc:description/>
  <dc:language>en-US</dc:language>
  <cp:lastModifiedBy>m.matumoto</cp:lastModifiedBy>
  <dcterms:modified xsi:type="dcterms:W3CDTF">2011-07-26T11:07:22Z</dcterms:modified>
  <cp:revision>255</cp:revision>
  <dc:subject/>
  <dc:title>スライド 1</dc:title>
</cp:coreProperties>
</file>